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5" r:id="rId2"/>
  </p:sldIdLst>
  <p:sldSz cx="7559675" cy="993616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583" userDrawn="1">
          <p15:clr>
            <a:srgbClr val="A4A3A4"/>
          </p15:clr>
        </p15:guide>
        <p15:guide id="3" orient="horz" pos="4286" userDrawn="1">
          <p15:clr>
            <a:srgbClr val="A4A3A4"/>
          </p15:clr>
        </p15:guide>
        <p15:guide id="4" orient="horz" pos="5692" userDrawn="1">
          <p15:clr>
            <a:srgbClr val="A4A3A4"/>
          </p15:clr>
        </p15:guide>
        <p15:guide id="5" orient="horz" pos="930" userDrawn="1">
          <p15:clr>
            <a:srgbClr val="A4A3A4"/>
          </p15:clr>
        </p15:guide>
        <p15:guide id="7" orient="horz" pos="3515" userDrawn="1">
          <p15:clr>
            <a:srgbClr val="A4A3A4"/>
          </p15:clr>
        </p15:guide>
        <p15:guide id="8" orient="horz" pos="2608" userDrawn="1">
          <p15:clr>
            <a:srgbClr val="A4A3A4"/>
          </p15:clr>
        </p15:guide>
        <p15:guide id="9" orient="horz" pos="4649" userDrawn="1">
          <p15:clr>
            <a:srgbClr val="A4A3A4"/>
          </p15:clr>
        </p15:guide>
        <p15:guide id="11" orient="horz" pos="4762" userDrawn="1">
          <p15:clr>
            <a:srgbClr val="A4A3A4"/>
          </p15:clr>
        </p15:guide>
        <p15:guide id="12" pos="467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腫瘍内科 近畿大学医学部" initials="腫近" lastIdx="1" clrIdx="0">
    <p:extLst>
      <p:ext uri="{19B8F6BF-5375-455C-9EA6-DF929625EA0E}">
        <p15:presenceInfo xmlns:p15="http://schemas.microsoft.com/office/powerpoint/2012/main" userId="b406ef13a87962d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B4C"/>
    <a:srgbClr val="CCECFF"/>
    <a:srgbClr val="61FF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スタイル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スタイル (濃色)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27"/>
  </p:normalViewPr>
  <p:slideViewPr>
    <p:cSldViewPr snapToGrid="0" snapToObjects="1" showGuides="1">
      <p:cViewPr varScale="1">
        <p:scale>
          <a:sx n="70" d="100"/>
          <a:sy n="70" d="100"/>
        </p:scale>
        <p:origin x="726" y="60"/>
      </p:cViewPr>
      <p:guideLst>
        <p:guide pos="3583"/>
        <p:guide orient="horz" pos="4286"/>
        <p:guide orient="horz" pos="5692"/>
        <p:guide orient="horz" pos="930"/>
        <p:guide orient="horz" pos="3515"/>
        <p:guide orient="horz" pos="2608"/>
        <p:guide orient="horz" pos="4649"/>
        <p:guide orient="horz" pos="4762"/>
        <p:guide pos="467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342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r">
              <a:defRPr sz="1200"/>
            </a:lvl1pPr>
          </a:lstStyle>
          <a:p>
            <a:fld id="{6F465158-8CF6-4271-801C-4DF7DC969FD4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7250" y="1243013"/>
            <a:ext cx="25479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4" tIns="45688" rIns="91374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0846"/>
            <a:ext cx="5441316" cy="3911312"/>
          </a:xfrm>
          <a:prstGeom prst="rect">
            <a:avLst/>
          </a:prstGeom>
        </p:spPr>
        <p:txBody>
          <a:bodyPr vert="horz" lIns="91374" tIns="45688" rIns="91374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342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r">
              <a:defRPr sz="1200"/>
            </a:lvl1pPr>
          </a:lstStyle>
          <a:p>
            <a:fld id="{2D556CFF-E290-41EC-82C8-7E6D0EEA4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46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26127"/>
            <a:ext cx="6425724" cy="345925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18786"/>
            <a:ext cx="5669756" cy="239893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57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29009"/>
            <a:ext cx="1630055" cy="842043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29009"/>
            <a:ext cx="4795669" cy="842043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0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379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77144"/>
            <a:ext cx="6520220" cy="413316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649412"/>
            <a:ext cx="6520220" cy="2173535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41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29011"/>
            <a:ext cx="6520220" cy="19205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35741"/>
            <a:ext cx="3198096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29460"/>
            <a:ext cx="3198096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35741"/>
            <a:ext cx="3213847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29460"/>
            <a:ext cx="3213847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1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37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30626"/>
            <a:ext cx="3827085" cy="706111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41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30626"/>
            <a:ext cx="3827085" cy="7061116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77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29011"/>
            <a:ext cx="6520220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45043"/>
            <a:ext cx="6520220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674DC-7F97-EF47-BEF5-67740BCEC122}" type="datetimeFigureOut">
              <a:rPr kumimoji="1" lang="ja-JP" altLang="en-US" smtClean="0"/>
              <a:t>2024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209353"/>
            <a:ext cx="2551390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60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5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package" Target="../embeddings/Microsoft_Excel_Worksheet.xlsx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E4ECDDE-94EC-EE94-D29A-FB8116772EE8}"/>
              </a:ext>
            </a:extLst>
          </p:cNvPr>
          <p:cNvSpPr txBox="1"/>
          <p:nvPr/>
        </p:nvSpPr>
        <p:spPr>
          <a:xfrm>
            <a:off x="145268" y="118393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8F9F3B3-B515-7DC6-7251-26D9D186195D}"/>
              </a:ext>
            </a:extLst>
          </p:cNvPr>
          <p:cNvSpPr txBox="1"/>
          <p:nvPr/>
        </p:nvSpPr>
        <p:spPr>
          <a:xfrm>
            <a:off x="377030" y="9113583"/>
            <a:ext cx="6805613" cy="6647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Figure S3. A heat map sorted by CIN z-score of hallmark-based gene signatures observed in the posttreatment sample in </a:t>
            </a:r>
            <a:r>
              <a:rPr lang="en-US" altLang="ja-JP" sz="1000" b="1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EGFR</a:t>
            </a: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-muta</a:t>
            </a: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ed</a:t>
            </a: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non-small-cell lung cancer</a:t>
            </a:r>
            <a:r>
              <a:rPr lang="en-US" altLang="ja-JP" sz="1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IN, chromosomal instability; r, </a:t>
            </a: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P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earson correlation coefficient.</a:t>
            </a:r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37A3B02A-F044-4120-28E0-A5F41B56FF0D}"/>
              </a:ext>
            </a:extLst>
          </p:cNvPr>
          <p:cNvGrpSpPr/>
          <p:nvPr/>
        </p:nvGrpSpPr>
        <p:grpSpPr>
          <a:xfrm>
            <a:off x="1652475" y="7664553"/>
            <a:ext cx="4994220" cy="1208964"/>
            <a:chOff x="1652475" y="7664553"/>
            <a:chExt cx="4994220" cy="1208964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3C529A80-2E0A-A376-7ED9-5CF7CAC56D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30866"/>
            <a:stretch/>
          </p:blipFill>
          <p:spPr>
            <a:xfrm>
              <a:off x="1778087" y="7907375"/>
              <a:ext cx="736444" cy="966142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4756D971-2FDA-2496-F108-F938AE53DE07}"/>
                </a:ext>
              </a:extLst>
            </p:cNvPr>
            <p:cNvSpPr txBox="1"/>
            <p:nvPr/>
          </p:nvSpPr>
          <p:spPr>
            <a:xfrm>
              <a:off x="1652475" y="7690429"/>
              <a:ext cx="11288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ype of hallmar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DF2F5284-57FD-2C13-2985-56AEDD66E9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81811" y="7907375"/>
              <a:ext cx="752475" cy="190500"/>
            </a:xfrm>
            <a:prstGeom prst="rect">
              <a:avLst/>
            </a:prstGeom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7BE9F2C5-6424-9019-2F06-36C7AD79BD3A}"/>
                </a:ext>
              </a:extLst>
            </p:cNvPr>
            <p:cNvSpPr txBox="1"/>
            <p:nvPr/>
          </p:nvSpPr>
          <p:spPr>
            <a:xfrm>
              <a:off x="2680826" y="8054983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47BCA2D-065F-A0C6-B174-5E00189CBB8F}"/>
                </a:ext>
              </a:extLst>
            </p:cNvPr>
            <p:cNvSpPr txBox="1"/>
            <p:nvPr/>
          </p:nvSpPr>
          <p:spPr>
            <a:xfrm>
              <a:off x="3013362" y="8061079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4B90911D-2EE0-8BE9-2938-56F7F68B4874}"/>
                </a:ext>
              </a:extLst>
            </p:cNvPr>
            <p:cNvSpPr txBox="1"/>
            <p:nvPr/>
          </p:nvSpPr>
          <p:spPr>
            <a:xfrm>
              <a:off x="3330355" y="8061079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E149184E-1398-4274-AF51-276974C2993D}"/>
                </a:ext>
              </a:extLst>
            </p:cNvPr>
            <p:cNvSpPr txBox="1"/>
            <p:nvPr/>
          </p:nvSpPr>
          <p:spPr>
            <a:xfrm>
              <a:off x="2782813" y="7664553"/>
              <a:ext cx="6046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z-score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6AE6B1D0-FFA1-197C-FCFE-5C73DE2369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13827" b="3995"/>
            <a:stretch/>
          </p:blipFill>
          <p:spPr>
            <a:xfrm>
              <a:off x="3720057" y="7690429"/>
              <a:ext cx="1272261" cy="569893"/>
            </a:xfrm>
            <a:prstGeom prst="rect">
              <a:avLst/>
            </a:prstGeom>
          </p:spPr>
        </p:pic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6E808D89-C3F6-D2E6-88A3-1029693446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14464"/>
            <a:stretch/>
          </p:blipFill>
          <p:spPr>
            <a:xfrm>
              <a:off x="5113689" y="7698281"/>
              <a:ext cx="1511739" cy="847173"/>
            </a:xfrm>
            <a:prstGeom prst="rect">
              <a:avLst/>
            </a:prstGeom>
            <a:ln>
              <a:noFill/>
            </a:ln>
          </p:spPr>
        </p:pic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0AA0EE45-E041-9398-0989-0B438D8D6986}"/>
                </a:ext>
              </a:extLst>
            </p:cNvPr>
            <p:cNvSpPr/>
            <p:nvPr/>
          </p:nvSpPr>
          <p:spPr>
            <a:xfrm>
              <a:off x="1673741" y="7687648"/>
              <a:ext cx="4972954" cy="1175236"/>
            </a:xfrm>
            <a:prstGeom prst="rect">
              <a:avLst/>
            </a:prstGeom>
            <a:noFill/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136919AD-02F7-01B1-FB9D-C63378C30B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5352307"/>
              </p:ext>
            </p:extLst>
          </p:nvPr>
        </p:nvGraphicFramePr>
        <p:xfrm>
          <a:off x="-1" y="913308"/>
          <a:ext cx="7546921" cy="66621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6" imgW="7886743" imgH="6962839" progId="Excel.Sheet.12">
                  <p:embed/>
                </p:oleObj>
              </mc:Choice>
              <mc:Fallback>
                <p:oleObj name="Worksheet" r:id="rId6" imgW="7886743" imgH="6962839" progId="Excel.Sheet.12">
                  <p:embed/>
                  <p:pic>
                    <p:nvPicPr>
                      <p:cNvPr id="11" name="オブジェクト 10">
                        <a:extLst>
                          <a:ext uri="{FF2B5EF4-FFF2-40B4-BE49-F238E27FC236}">
                            <a16:creationId xmlns:a16="http://schemas.microsoft.com/office/drawing/2014/main" id="{DB8F1240-B0E5-7C6D-2EE2-1690501C41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1" y="913308"/>
                        <a:ext cx="7546921" cy="66621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92417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22</TotalTime>
  <Words>47</Words>
  <Application>Microsoft Office PowerPoint</Application>
  <PresentationFormat>ユーザー設定</PresentationFormat>
  <Paragraphs>7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Worksheet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慎一郎</dc:creator>
  <cp:lastModifiedBy>仁雄 米阪</cp:lastModifiedBy>
  <cp:revision>629</cp:revision>
  <cp:lastPrinted>2024-06-06T11:43:21Z</cp:lastPrinted>
  <dcterms:created xsi:type="dcterms:W3CDTF">2021-02-12T07:53:00Z</dcterms:created>
  <dcterms:modified xsi:type="dcterms:W3CDTF">2024-12-14T03:06:46Z</dcterms:modified>
</cp:coreProperties>
</file>